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05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1F8C8-9B06-43D1-AA46-0FDE37E16DEC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FC2D6-AF77-48C3-B7A8-4288F56C952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91996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1F8C8-9B06-43D1-AA46-0FDE37E16DEC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FC2D6-AF77-48C3-B7A8-4288F56C952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360723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1F8C8-9B06-43D1-AA46-0FDE37E16DEC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FC2D6-AF77-48C3-B7A8-4288F56C952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47113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1F8C8-9B06-43D1-AA46-0FDE37E16DEC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FC2D6-AF77-48C3-B7A8-4288F56C952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712594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1F8C8-9B06-43D1-AA46-0FDE37E16DEC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FC2D6-AF77-48C3-B7A8-4288F56C952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711496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1F8C8-9B06-43D1-AA46-0FDE37E16DEC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FC2D6-AF77-48C3-B7A8-4288F56C952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58693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1F8C8-9B06-43D1-AA46-0FDE37E16DEC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FC2D6-AF77-48C3-B7A8-4288F56C952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208693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1F8C8-9B06-43D1-AA46-0FDE37E16DEC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FC2D6-AF77-48C3-B7A8-4288F56C952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353776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1F8C8-9B06-43D1-AA46-0FDE37E16DEC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FC2D6-AF77-48C3-B7A8-4288F56C952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03978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1F8C8-9B06-43D1-AA46-0FDE37E16DEC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FC2D6-AF77-48C3-B7A8-4288F56C952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1310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1F8C8-9B06-43D1-AA46-0FDE37E16DEC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FC2D6-AF77-48C3-B7A8-4288F56C952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74453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81F8C8-9B06-43D1-AA46-0FDE37E16DEC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FFC2D6-AF77-48C3-B7A8-4288F56C952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93028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12" Type="http://schemas.openxmlformats.org/officeDocument/2006/relationships/image" Target="../media/image9.png"/><Relationship Id="rId17" Type="http://schemas.openxmlformats.org/officeDocument/2006/relationships/image" Target="../media/image13.png"/><Relationship Id="rId2" Type="http://schemas.openxmlformats.org/officeDocument/2006/relationships/image" Target="../media/image1.png"/><Relationship Id="rId16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8.jpeg"/><Relationship Id="rId5" Type="http://schemas.openxmlformats.org/officeDocument/2006/relationships/image" Target="../media/image3.jpeg"/><Relationship Id="rId15" Type="http://schemas.openxmlformats.org/officeDocument/2006/relationships/image" Target="../media/image11.tiff"/><Relationship Id="rId10" Type="http://schemas.microsoft.com/office/2007/relationships/hdphoto" Target="../media/hdphoto2.wdp"/><Relationship Id="rId4" Type="http://schemas.openxmlformats.org/officeDocument/2006/relationships/image" Target="../media/image2.tiff"/><Relationship Id="rId9" Type="http://schemas.openxmlformats.org/officeDocument/2006/relationships/image" Target="../media/image7.png"/><Relationship Id="rId1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97A-2.tif"/>
          <p:cNvPicPr preferRelativeResize="0"/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16200000">
            <a:off x="3772396" y="184314"/>
            <a:ext cx="1493806" cy="1161378"/>
          </a:xfrm>
          <a:prstGeom prst="rect">
            <a:avLst/>
          </a:prstGeom>
          <a:ln w="25400">
            <a:noFill/>
          </a:ln>
        </p:spPr>
      </p:pic>
      <p:cxnSp>
        <p:nvCxnSpPr>
          <p:cNvPr id="5" name="Straight Arrow Connector 4"/>
          <p:cNvCxnSpPr/>
          <p:nvPr/>
        </p:nvCxnSpPr>
        <p:spPr>
          <a:xfrm>
            <a:off x="4436394" y="591700"/>
            <a:ext cx="0" cy="212267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Picture 6" descr="E:\Current photoes\E_Block\15-08\E14-1497-4-20X-1.tif"/>
          <p:cNvPicPr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181126" y="4703558"/>
            <a:ext cx="1228511" cy="1734759"/>
          </a:xfrm>
          <a:prstGeom prst="rect">
            <a:avLst/>
          </a:prstGeom>
          <a:noFill/>
          <a:ln w="6350">
            <a:noFill/>
          </a:ln>
        </p:spPr>
      </p:pic>
      <p:pic>
        <p:nvPicPr>
          <p:cNvPr id="7" name="Picture 13" descr="D:\Phenotyping_Microscopy_01-03_To_30-08\Back Crossses\4_Wet Season 2013\2_Sept_2013\06-09\17B-5087-94-20X-1.jpg"/>
          <p:cNvPicPr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173459" y="1563538"/>
            <a:ext cx="1254390" cy="1598853"/>
          </a:xfrm>
          <a:prstGeom prst="rect">
            <a:avLst/>
          </a:prstGeom>
          <a:noFill/>
        </p:spPr>
      </p:pic>
      <p:pic>
        <p:nvPicPr>
          <p:cNvPr id="8" name="Picture 7" descr="Y:\5_bmarathi\September-2013\11-09\25-B-20X-2.jpg"/>
          <p:cNvPicPr>
            <a:picLocks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5182167" y="18100"/>
            <a:ext cx="1245682" cy="1493805"/>
          </a:xfrm>
          <a:prstGeom prst="rect">
            <a:avLst/>
          </a:prstGeom>
          <a:noFill/>
        </p:spPr>
      </p:pic>
      <p:sp>
        <p:nvSpPr>
          <p:cNvPr id="9" name="Text Box 17"/>
          <p:cNvSpPr txBox="1">
            <a:spLocks noChangeArrowheads="1"/>
          </p:cNvSpPr>
          <p:nvPr/>
        </p:nvSpPr>
        <p:spPr bwMode="auto">
          <a:xfrm>
            <a:off x="2327128" y="151839"/>
            <a:ext cx="371095" cy="52042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r>
              <a:rPr lang="en-PH" altLang="en-US" sz="2800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endParaRPr lang="en-PH" altLang="en-US" sz="28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 Box 17"/>
          <p:cNvSpPr txBox="1">
            <a:spLocks noChangeArrowheads="1"/>
          </p:cNvSpPr>
          <p:nvPr/>
        </p:nvSpPr>
        <p:spPr bwMode="auto">
          <a:xfrm>
            <a:off x="2303252" y="3257974"/>
            <a:ext cx="371095" cy="52042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r>
              <a:rPr lang="en-PH" altLang="en-US" sz="2800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endParaRPr lang="en-PH" altLang="en-US" sz="28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 Box 17"/>
          <p:cNvSpPr txBox="1">
            <a:spLocks noChangeArrowheads="1"/>
          </p:cNvSpPr>
          <p:nvPr/>
        </p:nvSpPr>
        <p:spPr bwMode="auto">
          <a:xfrm>
            <a:off x="2327128" y="1635599"/>
            <a:ext cx="371095" cy="52042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r>
              <a:rPr lang="en-PH" altLang="en-US" sz="2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PH" altLang="en-US" sz="28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-61919" y="6418488"/>
            <a:ext cx="9205919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spAutoFit/>
          </a:bodyPr>
          <a:lstStyle/>
          <a:p>
            <a:pPr marL="514350" indent="-514350" algn="just"/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9:  Figure S6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enotypes of panicle, floret, and stigma. (a) IR68897B. (b) OL (IRGC110404). (c) The improved IR58025B possessing </a:t>
            </a:r>
            <a:r>
              <a:rPr lang="en-US" sz="11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STGL8.0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IRGC110404). (d) The improved IR68897B possessing </a:t>
            </a:r>
            <a:r>
              <a:rPr lang="en-US" sz="11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STGL8.0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IRGC92664). Red arrows point to the exserted stigma in each genotype.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4401957" y="2828877"/>
            <a:ext cx="0" cy="212267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20076" y="1292738"/>
            <a:ext cx="536575" cy="1889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8" cstate="print"/>
          <a:srcRect l="8865" r="26561" b="3977"/>
          <a:stretch>
            <a:fillRect/>
          </a:stretch>
        </p:blipFill>
        <p:spPr>
          <a:xfrm>
            <a:off x="2769495" y="18102"/>
            <a:ext cx="1013905" cy="1493804"/>
          </a:xfrm>
          <a:prstGeom prst="rect">
            <a:avLst/>
          </a:prstGeom>
        </p:spPr>
      </p:pic>
      <p:pic>
        <p:nvPicPr>
          <p:cNvPr id="16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7340" y="1322262"/>
            <a:ext cx="536575" cy="1938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16" descr="97A-2.tif"/>
          <p:cNvPicPr preferRelativeResize="0"/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16200000">
            <a:off x="3733228" y="1782358"/>
            <a:ext cx="1582736" cy="1150778"/>
          </a:xfrm>
          <a:prstGeom prst="rect">
            <a:avLst/>
          </a:prstGeom>
          <a:ln w="25400">
            <a:noFill/>
          </a:ln>
        </p:spPr>
      </p:pic>
      <p:pic>
        <p:nvPicPr>
          <p:cNvPr id="18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7380" y="2941132"/>
            <a:ext cx="536575" cy="1889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" name="Picture 18" descr="IMG_7382_O. grandiglumis.jpg"/>
          <p:cNvPicPr>
            <a:picLocks noChangeAspect="1"/>
          </p:cNvPicPr>
          <p:nvPr/>
        </p:nvPicPr>
        <p:blipFill>
          <a:blip r:embed="rId11" cstate="print"/>
          <a:stretch>
            <a:fillRect/>
          </a:stretch>
        </p:blipFill>
        <p:spPr>
          <a:xfrm>
            <a:off x="2745139" y="1564471"/>
            <a:ext cx="1079487" cy="1582737"/>
          </a:xfrm>
          <a:prstGeom prst="rect">
            <a:avLst/>
          </a:prstGeom>
          <a:ln w="12700">
            <a:noFill/>
          </a:ln>
        </p:spPr>
      </p:pic>
      <p:pic>
        <p:nvPicPr>
          <p:cNvPr id="20" name="Picture 2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2518" y="2908579"/>
            <a:ext cx="492108" cy="1777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1" name="Group 20"/>
          <p:cNvGrpSpPr/>
          <p:nvPr/>
        </p:nvGrpSpPr>
        <p:grpSpPr>
          <a:xfrm>
            <a:off x="3950880" y="4703559"/>
            <a:ext cx="1213076" cy="1734758"/>
            <a:chOff x="1826844" y="3507645"/>
            <a:chExt cx="1240717" cy="1928593"/>
          </a:xfrm>
        </p:grpSpPr>
        <p:pic>
          <p:nvPicPr>
            <p:cNvPr id="22" name="Picture 21" descr="97A-2.tif"/>
            <p:cNvPicPr preferRelativeResize="0"/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6200000">
              <a:off x="1448746" y="3885743"/>
              <a:ext cx="1922345" cy="1166150"/>
            </a:xfrm>
            <a:prstGeom prst="rect">
              <a:avLst/>
            </a:prstGeom>
            <a:ln w="25400">
              <a:noFill/>
            </a:ln>
          </p:spPr>
        </p:pic>
        <p:cxnSp>
          <p:nvCxnSpPr>
            <p:cNvPr id="23" name="Straight Arrow Connector 22"/>
            <p:cNvCxnSpPr/>
            <p:nvPr/>
          </p:nvCxnSpPr>
          <p:spPr>
            <a:xfrm flipH="1">
              <a:off x="2596129" y="4350570"/>
              <a:ext cx="71811" cy="236495"/>
            </a:xfrm>
            <a:prstGeom prst="straightConnector1">
              <a:avLst/>
            </a:prstGeom>
            <a:ln w="25400">
              <a:solidFill>
                <a:srgbClr val="C0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4" name="Picture 2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30986" y="5247325"/>
              <a:ext cx="536575" cy="1889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14"/>
          <a:srcRect l="2668" r="8538" b="1435"/>
          <a:stretch>
            <a:fillRect/>
          </a:stretch>
        </p:blipFill>
        <p:spPr>
          <a:xfrm>
            <a:off x="2726264" y="4656464"/>
            <a:ext cx="1121103" cy="1759085"/>
          </a:xfrm>
          <a:prstGeom prst="rect">
            <a:avLst/>
          </a:prstGeom>
        </p:spPr>
      </p:pic>
      <p:pic>
        <p:nvPicPr>
          <p:cNvPr id="26" name="Picture 12" descr="F:\1_Floral photoes_Feb-2012 _To_Sept-2014\Back Crossses\6_Wet Season 2014\October 2014\08-10-14\Selfing-4944-11-20x-1.tif"/>
          <p:cNvPicPr>
            <a:picLocks noChangeAspect="1" noChangeArrowheads="1"/>
          </p:cNvPicPr>
          <p:nvPr/>
        </p:nvPicPr>
        <p:blipFill rotWithShape="1">
          <a:blip r:embed="rId15" cstate="print"/>
          <a:srcRect l="21280" t="16208" r="16014" b="5197"/>
          <a:stretch>
            <a:fillRect/>
          </a:stretch>
        </p:blipFill>
        <p:spPr bwMode="auto">
          <a:xfrm>
            <a:off x="5163955" y="3196605"/>
            <a:ext cx="1245682" cy="1462843"/>
          </a:xfrm>
          <a:prstGeom prst="rect">
            <a:avLst/>
          </a:prstGeom>
          <a:noFill/>
        </p:spPr>
      </p:pic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16" cstate="print"/>
          <a:srcRect r="9213" b="3835"/>
          <a:stretch>
            <a:fillRect/>
          </a:stretch>
        </p:blipFill>
        <p:spPr>
          <a:xfrm>
            <a:off x="2726264" y="3196605"/>
            <a:ext cx="1080150" cy="1462843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17" cstate="print"/>
          <a:stretch>
            <a:fillRect/>
          </a:stretch>
        </p:blipFill>
        <p:spPr>
          <a:xfrm>
            <a:off x="3943156" y="3188146"/>
            <a:ext cx="1107447" cy="1486157"/>
          </a:xfrm>
          <a:prstGeom prst="rect">
            <a:avLst/>
          </a:prstGeom>
        </p:spPr>
      </p:pic>
      <p:cxnSp>
        <p:nvCxnSpPr>
          <p:cNvPr id="29" name="Straight Arrow Connector 28"/>
          <p:cNvCxnSpPr/>
          <p:nvPr/>
        </p:nvCxnSpPr>
        <p:spPr>
          <a:xfrm>
            <a:off x="4279960" y="3931224"/>
            <a:ext cx="138234" cy="237784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4239493" y="2266159"/>
            <a:ext cx="80935" cy="19361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 flipH="1">
            <a:off x="4749020" y="3928026"/>
            <a:ext cx="78685" cy="240982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 flipH="1">
            <a:off x="4827705" y="2072549"/>
            <a:ext cx="67962" cy="19361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>
            <a:off x="4222024" y="5746817"/>
            <a:ext cx="161448" cy="96805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4445020" y="565822"/>
            <a:ext cx="97923" cy="131676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 Box 17"/>
          <p:cNvSpPr txBox="1">
            <a:spLocks noChangeArrowheads="1"/>
          </p:cNvSpPr>
          <p:nvPr/>
        </p:nvSpPr>
        <p:spPr bwMode="auto">
          <a:xfrm>
            <a:off x="2300115" y="4858529"/>
            <a:ext cx="371095" cy="52042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r>
              <a:rPr lang="en-US" altLang="en-US" sz="2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PH" altLang="en-US" sz="28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55582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jela Priency D.</dc:creator>
  <cp:lastModifiedBy>Anjela Priency D.</cp:lastModifiedBy>
  <cp:revision>1</cp:revision>
  <dcterms:created xsi:type="dcterms:W3CDTF">2021-09-02T09:32:32Z</dcterms:created>
  <dcterms:modified xsi:type="dcterms:W3CDTF">2021-09-02T09:32:44Z</dcterms:modified>
</cp:coreProperties>
</file>